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373"/>
    <p:restoredTop sz="94644"/>
  </p:normalViewPr>
  <p:slideViewPr>
    <p:cSldViewPr snapToGrid="0" snapToObjects="1">
      <p:cViewPr>
        <p:scale>
          <a:sx n="220" d="100"/>
          <a:sy n="220" d="100"/>
        </p:scale>
        <p:origin x="56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5C1DE-1631-F246-8FC3-6D439D27B5EF}" type="datetimeFigureOut">
              <a:rPr lang="en-US" smtClean="0"/>
              <a:t>7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39E49-10C9-6940-AC40-0E53F9EA65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61416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5C1DE-1631-F246-8FC3-6D439D27B5EF}" type="datetimeFigureOut">
              <a:rPr lang="en-US" smtClean="0"/>
              <a:t>7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39E49-10C9-6940-AC40-0E53F9EA65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57038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5C1DE-1631-F246-8FC3-6D439D27B5EF}" type="datetimeFigureOut">
              <a:rPr lang="en-US" smtClean="0"/>
              <a:t>7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39E49-10C9-6940-AC40-0E53F9EA65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46400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5C1DE-1631-F246-8FC3-6D439D27B5EF}" type="datetimeFigureOut">
              <a:rPr lang="en-US" smtClean="0"/>
              <a:t>7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39E49-10C9-6940-AC40-0E53F9EA65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28432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5C1DE-1631-F246-8FC3-6D439D27B5EF}" type="datetimeFigureOut">
              <a:rPr lang="en-US" smtClean="0"/>
              <a:t>7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39E49-10C9-6940-AC40-0E53F9EA65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1537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5C1DE-1631-F246-8FC3-6D439D27B5EF}" type="datetimeFigureOut">
              <a:rPr lang="en-US" smtClean="0"/>
              <a:t>7/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39E49-10C9-6940-AC40-0E53F9EA65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87189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5C1DE-1631-F246-8FC3-6D439D27B5EF}" type="datetimeFigureOut">
              <a:rPr lang="en-US" smtClean="0"/>
              <a:t>7/1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39E49-10C9-6940-AC40-0E53F9EA65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1725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5C1DE-1631-F246-8FC3-6D439D27B5EF}" type="datetimeFigureOut">
              <a:rPr lang="en-US" smtClean="0"/>
              <a:t>7/1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39E49-10C9-6940-AC40-0E53F9EA65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03438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5C1DE-1631-F246-8FC3-6D439D27B5EF}" type="datetimeFigureOut">
              <a:rPr lang="en-US" smtClean="0"/>
              <a:t>7/1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39E49-10C9-6940-AC40-0E53F9EA65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21433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5C1DE-1631-F246-8FC3-6D439D27B5EF}" type="datetimeFigureOut">
              <a:rPr lang="en-US" smtClean="0"/>
              <a:t>7/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39E49-10C9-6940-AC40-0E53F9EA65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67013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5C1DE-1631-F246-8FC3-6D439D27B5EF}" type="datetimeFigureOut">
              <a:rPr lang="en-US" smtClean="0"/>
              <a:t>7/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F39E49-10C9-6940-AC40-0E53F9EA65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78200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C5C1DE-1631-F246-8FC3-6D439D27B5EF}" type="datetimeFigureOut">
              <a:rPr lang="en-US" smtClean="0"/>
              <a:t>7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F39E49-10C9-6940-AC40-0E53F9EA65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1584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B3B69A3-8943-9A49-A4B3-FF1983963685}"/>
              </a:ext>
            </a:extLst>
          </p:cNvPr>
          <p:cNvSpPr txBox="1"/>
          <p:nvPr/>
        </p:nvSpPr>
        <p:spPr>
          <a:xfrm flipH="1">
            <a:off x="279895" y="100361"/>
            <a:ext cx="42921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Figure 5.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CAF339BE-7FE8-C44E-98E6-1C3E7A9A93E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b="45390"/>
          <a:stretch/>
        </p:blipFill>
        <p:spPr>
          <a:xfrm>
            <a:off x="380256" y="645170"/>
            <a:ext cx="5961540" cy="207488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A1A61F59-0385-B64C-899D-310ED3807D4D}"/>
              </a:ext>
            </a:extLst>
          </p:cNvPr>
          <p:cNvSpPr txBox="1"/>
          <p:nvPr/>
        </p:nvSpPr>
        <p:spPr>
          <a:xfrm>
            <a:off x="738282" y="3790035"/>
            <a:ext cx="5472973" cy="8925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rvival of GBM patients classified according to CIC</a:t>
            </a:r>
          </a:p>
          <a:p>
            <a:pPr algn="just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Kaplan-Meier plot of GBM patient survival according to CIC classification. Patients were </a:t>
            </a:r>
          </a:p>
          <a:p>
            <a:pPr algn="just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lassified into CICs according to the data in Figure 6 of the main manuscript. Survival fraction </a:t>
            </a:r>
          </a:p>
          <a:p>
            <a:pPr algn="just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as determined using the data provided in the TCGA database. </a:t>
            </a:r>
          </a:p>
          <a:p>
            <a:pPr algn="just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F5A109ED-E148-A546-B7F4-ED18460C945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2280"/>
          <a:stretch/>
        </p:blipFill>
        <p:spPr>
          <a:xfrm>
            <a:off x="90889" y="2918413"/>
            <a:ext cx="5961540" cy="6732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683448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</TotalTime>
  <Words>53</Words>
  <Application>Microsoft Macintosh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5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raham Cook</dc:creator>
  <cp:lastModifiedBy>Erica Watson</cp:lastModifiedBy>
  <cp:revision>8</cp:revision>
  <cp:lastPrinted>2019-06-12T07:33:59Z</cp:lastPrinted>
  <dcterms:created xsi:type="dcterms:W3CDTF">2018-07-17T15:02:14Z</dcterms:created>
  <dcterms:modified xsi:type="dcterms:W3CDTF">2019-07-01T14:57:33Z</dcterms:modified>
</cp:coreProperties>
</file>